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94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7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E1CDA74D-20A9-B440-8191-E3C4091AC777}"/>
              </a:ext>
            </a:extLst>
          </p:cNvPr>
          <p:cNvGrpSpPr/>
          <p:nvPr/>
        </p:nvGrpSpPr>
        <p:grpSpPr>
          <a:xfrm>
            <a:off x="289669" y="945672"/>
            <a:ext cx="6310239" cy="5518686"/>
            <a:chOff x="455929" y="945673"/>
            <a:chExt cx="5965395" cy="5217099"/>
          </a:xfrm>
        </p:grpSpPr>
        <p:pic>
          <p:nvPicPr>
            <p:cNvPr id="4" name="図 3" descr="20170601_1605_24_PYG#2111_005.bmp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5929" y="3671116"/>
              <a:ext cx="2910161" cy="2182621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4713016" y="5842719"/>
              <a:ext cx="492809" cy="320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 err="1">
                  <a:latin typeface="Symbol" pitchFamily="2" charset="2"/>
                </a:rPr>
                <a:t>D</a:t>
              </a:r>
              <a:r>
                <a:rPr lang="en-US" altLang="ja-JP" sz="1600" i="1" dirty="0" err="1"/>
                <a:t>csl</a:t>
              </a:r>
              <a:endParaRPr lang="ja-JP" altLang="en-US" sz="1600" i="1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708372" y="5842719"/>
              <a:ext cx="592825" cy="320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 err="1">
                  <a:latin typeface="Symbol" pitchFamily="2" charset="2"/>
                </a:rPr>
                <a:t>D</a:t>
              </a:r>
              <a:r>
                <a:rPr lang="en-US" altLang="ja-JP" sz="1600" i="1" dirty="0" err="1"/>
                <a:t>lolA</a:t>
              </a:r>
              <a:endParaRPr lang="ja-JP" altLang="en-US" sz="1600" i="1"/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6E91B6B5-D0C9-3949-AD10-12933FDA126E}"/>
                </a:ext>
              </a:extLst>
            </p:cNvPr>
            <p:cNvGrpSpPr/>
            <p:nvPr/>
          </p:nvGrpSpPr>
          <p:grpSpPr>
            <a:xfrm>
              <a:off x="3504628" y="945673"/>
              <a:ext cx="2916696" cy="2473625"/>
              <a:chOff x="463682" y="578337"/>
              <a:chExt cx="2916696" cy="2473625"/>
            </a:xfrm>
          </p:grpSpPr>
          <p:pic>
            <p:nvPicPr>
              <p:cNvPr id="5" name="図 4" descr="20170601_1632_28_PYG#3180_003.bmp"/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3682" y="578337"/>
                <a:ext cx="2916696" cy="2187522"/>
              </a:xfrm>
              <a:prstGeom prst="rect">
                <a:avLst/>
              </a:prstGeom>
            </p:spPr>
          </p:pic>
          <p:sp>
            <p:nvSpPr>
              <p:cNvPr id="9" name="テキスト ボックス 8"/>
              <p:cNvSpPr txBox="1"/>
              <p:nvPr/>
            </p:nvSpPr>
            <p:spPr>
              <a:xfrm>
                <a:off x="1695147" y="2731909"/>
                <a:ext cx="641318" cy="3200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 err="1">
                    <a:latin typeface="Symbol" pitchFamily="2" charset="2"/>
                  </a:rPr>
                  <a:t>D</a:t>
                </a:r>
                <a:r>
                  <a:rPr lang="en-US" altLang="ja-JP" sz="1600" i="1" dirty="0" err="1"/>
                  <a:t>sprB</a:t>
                </a:r>
                <a:endParaRPr lang="ja-JP" altLang="en-US" sz="1600" i="1"/>
              </a:p>
            </p:txBody>
          </p:sp>
        </p:grpSp>
        <p:pic>
          <p:nvPicPr>
            <p:cNvPr id="10" name="図 9" descr="20170601_1540_15_PYG#38_007.bmp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04628" y="3671548"/>
              <a:ext cx="2909585" cy="2182189"/>
            </a:xfrm>
            <a:prstGeom prst="rect">
              <a:avLst/>
            </a:prstGeom>
          </p:spPr>
        </p:pic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93881A6F-7738-044D-9D37-C10E9913531D}"/>
                </a:ext>
              </a:extLst>
            </p:cNvPr>
            <p:cNvGrpSpPr/>
            <p:nvPr/>
          </p:nvGrpSpPr>
          <p:grpSpPr>
            <a:xfrm>
              <a:off x="479325" y="945673"/>
              <a:ext cx="2910161" cy="2473625"/>
              <a:chOff x="3518340" y="578337"/>
              <a:chExt cx="2910161" cy="2473625"/>
            </a:xfrm>
          </p:grpSpPr>
          <p:sp>
            <p:nvSpPr>
              <p:cNvPr id="8" name="テキスト ボックス 7"/>
              <p:cNvSpPr txBox="1"/>
              <p:nvPr/>
            </p:nvSpPr>
            <p:spPr>
              <a:xfrm>
                <a:off x="4776854" y="2731909"/>
                <a:ext cx="441284" cy="3200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/>
                  <a:t>WT</a:t>
                </a:r>
                <a:endParaRPr lang="ja-JP" altLang="en-US" sz="1600"/>
              </a:p>
            </p:txBody>
          </p:sp>
          <p:pic>
            <p:nvPicPr>
              <p:cNvPr id="11" name="図 10" descr="20170601_1455_40_PYG#4_011.bmp"/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18340" y="578337"/>
                <a:ext cx="2910161" cy="2182621"/>
              </a:xfrm>
              <a:prstGeom prst="rect">
                <a:avLst/>
              </a:prstGeom>
            </p:spPr>
          </p:pic>
        </p:grpSp>
      </p:grpSp>
      <p:sp>
        <p:nvSpPr>
          <p:cNvPr id="12" name="テキスト ボックス 11"/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7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B291DF7-6983-1E46-A45D-8C50C6B17EDB}"/>
              </a:ext>
            </a:extLst>
          </p:cNvPr>
          <p:cNvSpPr txBox="1"/>
          <p:nvPr/>
        </p:nvSpPr>
        <p:spPr>
          <a:xfrm>
            <a:off x="2497334" y="526535"/>
            <a:ext cx="18633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/>
              <a:t>0.3% A-PYG(15 mM)</a:t>
            </a:r>
            <a:endParaRPr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61092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1</TotalTime>
  <Words>229</Words>
  <Application>Microsoft Macintosh PowerPoint</Application>
  <PresentationFormat>画面に合わせる 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2</cp:revision>
  <cp:lastPrinted>2020-08-18T02:49:06Z</cp:lastPrinted>
  <dcterms:created xsi:type="dcterms:W3CDTF">2017-02-28T00:50:21Z</dcterms:created>
  <dcterms:modified xsi:type="dcterms:W3CDTF">2020-11-20T14:29:16Z</dcterms:modified>
</cp:coreProperties>
</file>